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216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Revise\H1975+MAP4K4%20inhibitor%20MTT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Revise\Wound%20healing\wound%20healing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7948932853981485E-2"/>
          <c:y val="5.0925925925925923E-2"/>
          <c:w val="0.8781293514781241"/>
          <c:h val="0.83309419655876349"/>
        </c:manualLayout>
      </c:layout>
      <c:lineChart>
        <c:grouping val="standard"/>
        <c:varyColors val="0"/>
        <c:ser>
          <c:idx val="0"/>
          <c:order val="0"/>
          <c:tx>
            <c:strRef>
              <c:f>revise!$B$3</c:f>
              <c:strCache>
                <c:ptCount val="1"/>
                <c:pt idx="0">
                  <c:v>H1975+DMSO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revise!$C$7:$I$7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11678381476124056</c:v>
                  </c:pt>
                  <c:pt idx="2">
                    <c:v>0.20733151189337484</c:v>
                  </c:pt>
                  <c:pt idx="3">
                    <c:v>0</c:v>
                  </c:pt>
                  <c:pt idx="4">
                    <c:v>0.86119748674107832</c:v>
                  </c:pt>
                  <c:pt idx="5">
                    <c:v>0</c:v>
                  </c:pt>
                  <c:pt idx="6">
                    <c:v>1.6943192153000763</c:v>
                  </c:pt>
                </c:numCache>
              </c:numRef>
            </c:plus>
            <c:minus>
              <c:numRef>
                <c:f>revise!$C$7:$I$7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11678381476124056</c:v>
                  </c:pt>
                  <c:pt idx="2">
                    <c:v>0.20733151189337484</c:v>
                  </c:pt>
                  <c:pt idx="3">
                    <c:v>0</c:v>
                  </c:pt>
                  <c:pt idx="4">
                    <c:v>0.86119748674107832</c:v>
                  </c:pt>
                  <c:pt idx="5">
                    <c:v>0</c:v>
                  </c:pt>
                  <c:pt idx="6">
                    <c:v>1.6943192153000763</c:v>
                  </c:pt>
                </c:numCache>
              </c:numRef>
            </c:minus>
          </c:errBars>
          <c:cat>
            <c:numRef>
              <c:f>revise!$C$2:$I$2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4">
                  <c:v>5</c:v>
                </c:pt>
                <c:pt idx="6">
                  <c:v>7</c:v>
                </c:pt>
              </c:numCache>
            </c:numRef>
          </c:cat>
          <c:val>
            <c:numRef>
              <c:f>revise!$C$3:$I$3</c:f>
              <c:numCache>
                <c:formatCode>General</c:formatCode>
                <c:ptCount val="7"/>
                <c:pt idx="0">
                  <c:v>1</c:v>
                </c:pt>
                <c:pt idx="1">
                  <c:v>1.9738945486973936</c:v>
                </c:pt>
                <c:pt idx="2">
                  <c:v>3.9357781681656996</c:v>
                </c:pt>
                <c:pt idx="4">
                  <c:v>14.008525969873466</c:v>
                </c:pt>
                <c:pt idx="6">
                  <c:v>26.431852636197032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revise!$B$4</c:f>
              <c:strCache>
                <c:ptCount val="1"/>
                <c:pt idx="0">
                  <c:v>H1975+PF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revise!$C$8:$I$8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11843902895829676</c:v>
                  </c:pt>
                  <c:pt idx="2">
                    <c:v>0.1046165909990555</c:v>
                  </c:pt>
                  <c:pt idx="3">
                    <c:v>0</c:v>
                  </c:pt>
                  <c:pt idx="4">
                    <c:v>0.58390284444855234</c:v>
                  </c:pt>
                  <c:pt idx="5">
                    <c:v>0</c:v>
                  </c:pt>
                  <c:pt idx="6">
                    <c:v>0.72515862326201108</c:v>
                  </c:pt>
                </c:numCache>
              </c:numRef>
            </c:plus>
            <c:minus>
              <c:numRef>
                <c:f>revise!$C$8:$I$8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11843902895829676</c:v>
                  </c:pt>
                  <c:pt idx="2">
                    <c:v>0.1046165909990555</c:v>
                  </c:pt>
                  <c:pt idx="3">
                    <c:v>0</c:v>
                  </c:pt>
                  <c:pt idx="4">
                    <c:v>0.58390284444855234</c:v>
                  </c:pt>
                  <c:pt idx="5">
                    <c:v>0</c:v>
                  </c:pt>
                  <c:pt idx="6">
                    <c:v>0.72515862326201108</c:v>
                  </c:pt>
                </c:numCache>
              </c:numRef>
            </c:minus>
          </c:errBars>
          <c:cat>
            <c:numRef>
              <c:f>revise!$C$2:$I$2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4">
                  <c:v>5</c:v>
                </c:pt>
                <c:pt idx="6">
                  <c:v>7</c:v>
                </c:pt>
              </c:numCache>
            </c:numRef>
          </c:cat>
          <c:val>
            <c:numRef>
              <c:f>revise!$C$4:$I$4</c:f>
              <c:numCache>
                <c:formatCode>General</c:formatCode>
                <c:ptCount val="7"/>
                <c:pt idx="0">
                  <c:v>1</c:v>
                </c:pt>
                <c:pt idx="1">
                  <c:v>1.2598931854730433</c:v>
                </c:pt>
                <c:pt idx="2">
                  <c:v>2.0375439282897601</c:v>
                </c:pt>
                <c:pt idx="4">
                  <c:v>4.4646927178825271</c:v>
                </c:pt>
                <c:pt idx="6">
                  <c:v>10.27776860779710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2791168"/>
        <c:axId val="92792704"/>
      </c:lineChart>
      <c:catAx>
        <c:axId val="92791168"/>
        <c:scaling>
          <c:orientation val="minMax"/>
        </c:scaling>
        <c:delete val="0"/>
        <c:axPos val="b"/>
        <c:numFmt formatCode="General" sourceLinked="1"/>
        <c:majorTickMark val="none"/>
        <c:minorTickMark val="in"/>
        <c:tickLblPos val="nextTo"/>
        <c:spPr>
          <a:ln w="12700">
            <a:solidFill>
              <a:schemeClr val="tx1"/>
            </a:solidFill>
          </a:ln>
        </c:spPr>
        <c:crossAx val="92792704"/>
        <c:crosses val="autoZero"/>
        <c:auto val="1"/>
        <c:lblAlgn val="ctr"/>
        <c:lblOffset val="100"/>
        <c:noMultiLvlLbl val="0"/>
      </c:catAx>
      <c:valAx>
        <c:axId val="92792704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zh-CN"/>
          </a:p>
        </c:txPr>
        <c:crossAx val="9279116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9.8968217208143097E-2"/>
          <c:y val="5.5171697287839022E-2"/>
          <c:w val="0.38993478756331929"/>
          <c:h val="0.17709682123067949"/>
        </c:manualLayout>
      </c:layout>
      <c:overlay val="0"/>
      <c:txPr>
        <a:bodyPr/>
        <a:lstStyle/>
        <a:p>
          <a:pPr>
            <a:defRPr>
              <a:latin typeface="Arial" pitchFamily="34" charset="0"/>
              <a:cs typeface="Arial" pitchFamily="34" charset="0"/>
            </a:defRPr>
          </a:pPr>
          <a:endParaRPr lang="zh-CN"/>
        </a:p>
      </c:txPr>
    </c:legend>
    <c:plotVisOnly val="1"/>
    <c:dispBlanksAs val="span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025282341836695"/>
          <c:y val="5.0925925925925923E-2"/>
          <c:w val="0.7715954265951126"/>
          <c:h val="0.5945126127471366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REVISE!$B$4</c:f>
              <c:strCache>
                <c:ptCount val="1"/>
                <c:pt idx="0">
                  <c:v>0 hr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REVISE!$F$3:$G$3</c:f>
                <c:numCache>
                  <c:formatCode>General</c:formatCode>
                  <c:ptCount val="2"/>
                  <c:pt idx="0">
                    <c:v>2.2080936252752834</c:v>
                  </c:pt>
                  <c:pt idx="1">
                    <c:v>2.287593361250816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REVISE!$C$3:$D$3</c:f>
              <c:strCache>
                <c:ptCount val="2"/>
                <c:pt idx="0">
                  <c:v>H1975+DMSO</c:v>
                </c:pt>
                <c:pt idx="1">
                  <c:v>H1975+PF</c:v>
                </c:pt>
              </c:strCache>
            </c:strRef>
          </c:cat>
          <c:val>
            <c:numRef>
              <c:f>REVISE!$C$4:$D$4</c:f>
              <c:numCache>
                <c:formatCode>General</c:formatCode>
                <c:ptCount val="2"/>
                <c:pt idx="0">
                  <c:v>100.00000000363909</c:v>
                </c:pt>
                <c:pt idx="1">
                  <c:v>100.00000000370899</c:v>
                </c:pt>
              </c:numCache>
            </c:numRef>
          </c:val>
        </c:ser>
        <c:ser>
          <c:idx val="1"/>
          <c:order val="1"/>
          <c:tx>
            <c:strRef>
              <c:f>REVISE!$B$5</c:f>
              <c:strCache>
                <c:ptCount val="1"/>
                <c:pt idx="0">
                  <c:v>24 hr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REVISE!$I$3:$J$3</c:f>
                <c:numCache>
                  <c:formatCode>General</c:formatCode>
                  <c:ptCount val="2"/>
                  <c:pt idx="0">
                    <c:v>7.231558366165955</c:v>
                  </c:pt>
                  <c:pt idx="1">
                    <c:v>8.585403224364014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REVISE!$C$3:$D$3</c:f>
              <c:strCache>
                <c:ptCount val="2"/>
                <c:pt idx="0">
                  <c:v>H1975+DMSO</c:v>
                </c:pt>
                <c:pt idx="1">
                  <c:v>H1975+PF</c:v>
                </c:pt>
              </c:strCache>
            </c:strRef>
          </c:cat>
          <c:val>
            <c:numRef>
              <c:f>REVISE!$C$5:$D$5</c:f>
              <c:numCache>
                <c:formatCode>General</c:formatCode>
                <c:ptCount val="2"/>
                <c:pt idx="0">
                  <c:v>47.30071508023439</c:v>
                </c:pt>
                <c:pt idx="1">
                  <c:v>84.877909470519242</c:v>
                </c:pt>
              </c:numCache>
            </c:numRef>
          </c:val>
        </c:ser>
        <c:ser>
          <c:idx val="2"/>
          <c:order val="2"/>
          <c:tx>
            <c:strRef>
              <c:f>REVISE!$B$6</c:f>
              <c:strCache>
                <c:ptCount val="1"/>
                <c:pt idx="0">
                  <c:v>48 hr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REVISE!$L$3:$M$3</c:f>
                <c:numCache>
                  <c:formatCode>General</c:formatCode>
                  <c:ptCount val="2"/>
                  <c:pt idx="0">
                    <c:v>1.2119396921508021</c:v>
                  </c:pt>
                  <c:pt idx="1">
                    <c:v>10.0356114935102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REVISE!$C$3:$D$3</c:f>
              <c:strCache>
                <c:ptCount val="2"/>
                <c:pt idx="0">
                  <c:v>H1975+DMSO</c:v>
                </c:pt>
                <c:pt idx="1">
                  <c:v>H1975+PF</c:v>
                </c:pt>
              </c:strCache>
            </c:strRef>
          </c:cat>
          <c:val>
            <c:numRef>
              <c:f>REVISE!$C$6:$D$6</c:f>
              <c:numCache>
                <c:formatCode>General</c:formatCode>
                <c:ptCount val="2"/>
                <c:pt idx="0">
                  <c:v>5.7770337890346273</c:v>
                </c:pt>
                <c:pt idx="1">
                  <c:v>60.91007379252714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2979712"/>
        <c:axId val="42981248"/>
      </c:barChart>
      <c:catAx>
        <c:axId val="42979712"/>
        <c:scaling>
          <c:orientation val="minMax"/>
        </c:scaling>
        <c:delete val="0"/>
        <c:axPos val="b"/>
        <c:majorTickMark val="none"/>
        <c:minorTickMark val="in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zh-CN"/>
          </a:p>
        </c:txPr>
        <c:crossAx val="42981248"/>
        <c:crosses val="autoZero"/>
        <c:auto val="1"/>
        <c:lblAlgn val="ctr"/>
        <c:lblOffset val="100"/>
        <c:noMultiLvlLbl val="0"/>
      </c:catAx>
      <c:valAx>
        <c:axId val="4298124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zh-CN"/>
          </a:p>
        </c:txPr>
        <c:crossAx val="4297971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3165240094095826"/>
          <c:y val="2.7201641469144503E-2"/>
          <c:w val="0.75806311376030677"/>
          <c:h val="0.1166189122193059"/>
        </c:manualLayout>
      </c:layout>
      <c:overlay val="0"/>
      <c:txPr>
        <a:bodyPr/>
        <a:lstStyle/>
        <a:p>
          <a:pPr>
            <a:defRPr>
              <a:latin typeface="Arial" pitchFamily="34" charset="0"/>
              <a:cs typeface="Arial" pitchFamily="34" charset="0"/>
            </a:defRPr>
          </a:pPr>
          <a:endParaRPr lang="zh-CN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0.tiff"/><Relationship Id="rId18" Type="http://schemas.openxmlformats.org/officeDocument/2006/relationships/image" Target="../media/image15.png"/><Relationship Id="rId3" Type="http://schemas.openxmlformats.org/officeDocument/2006/relationships/image" Target="../media/image1.png"/><Relationship Id="rId7" Type="http://schemas.openxmlformats.org/officeDocument/2006/relationships/image" Target="../media/image5.tiff"/><Relationship Id="rId12" Type="http://schemas.openxmlformats.org/officeDocument/2006/relationships/image" Target="../media/image9.tiff"/><Relationship Id="rId17" Type="http://schemas.openxmlformats.org/officeDocument/2006/relationships/image" Target="../media/image14.png"/><Relationship Id="rId2" Type="http://schemas.openxmlformats.org/officeDocument/2006/relationships/chart" Target="../charts/chart1.xml"/><Relationship Id="rId16" Type="http://schemas.openxmlformats.org/officeDocument/2006/relationships/image" Target="../media/image13.png"/><Relationship Id="rId20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8.tiff"/><Relationship Id="rId5" Type="http://schemas.openxmlformats.org/officeDocument/2006/relationships/image" Target="../media/image3.tiff"/><Relationship Id="rId15" Type="http://schemas.openxmlformats.org/officeDocument/2006/relationships/image" Target="../media/image12.tiff"/><Relationship Id="rId10" Type="http://schemas.openxmlformats.org/officeDocument/2006/relationships/image" Target="../media/image7.tiff"/><Relationship Id="rId19" Type="http://schemas.openxmlformats.org/officeDocument/2006/relationships/image" Target="../media/image16.png"/><Relationship Id="rId4" Type="http://schemas.openxmlformats.org/officeDocument/2006/relationships/image" Target="../media/image2.tiff"/><Relationship Id="rId9" Type="http://schemas.openxmlformats.org/officeDocument/2006/relationships/chart" Target="../charts/chart2.xml"/><Relationship Id="rId14" Type="http://schemas.openxmlformats.org/officeDocument/2006/relationships/image" Target="../media/image1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6" name="Group 55"/>
          <p:cNvGrpSpPr/>
          <p:nvPr/>
        </p:nvGrpSpPr>
        <p:grpSpPr>
          <a:xfrm>
            <a:off x="2100674" y="76200"/>
            <a:ext cx="3614326" cy="2376707"/>
            <a:chOff x="1414874" y="76200"/>
            <a:chExt cx="3614326" cy="2376707"/>
          </a:xfrm>
        </p:grpSpPr>
        <p:grpSp>
          <p:nvGrpSpPr>
            <p:cNvPr id="11" name="组合 10"/>
            <p:cNvGrpSpPr/>
            <p:nvPr/>
          </p:nvGrpSpPr>
          <p:grpSpPr>
            <a:xfrm>
              <a:off x="1485415" y="178966"/>
              <a:ext cx="3543785" cy="2273941"/>
              <a:chOff x="642392" y="430880"/>
              <a:chExt cx="3953231" cy="2273941"/>
            </a:xfrm>
          </p:grpSpPr>
          <p:graphicFrame>
            <p:nvGraphicFramePr>
              <p:cNvPr id="10" name="图表 9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275632576"/>
                  </p:ext>
                </p:extLst>
              </p:nvPr>
            </p:nvGraphicFramePr>
            <p:xfrm>
              <a:off x="911310" y="430880"/>
              <a:ext cx="3444666" cy="226878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3" name="TextBox 2"/>
              <p:cNvSpPr txBox="1"/>
              <p:nvPr/>
            </p:nvSpPr>
            <p:spPr>
              <a:xfrm>
                <a:off x="642392" y="480142"/>
                <a:ext cx="338554" cy="2042105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 algn="ctr"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 change of cell number</a:t>
                </a:r>
              </a:p>
            </p:txBody>
          </p:sp>
          <p:sp>
            <p:nvSpPr>
              <p:cNvPr id="4" name="TextBox 3"/>
              <p:cNvSpPr txBox="1"/>
              <p:nvPr/>
            </p:nvSpPr>
            <p:spPr>
              <a:xfrm>
                <a:off x="4064471" y="2458600"/>
                <a:ext cx="53115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ay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3111317" y="1945936"/>
                <a:ext cx="1539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3987485" y="1568262"/>
                <a:ext cx="1539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" name="TextBox 8"/>
            <p:cNvSpPr txBox="1"/>
            <p:nvPr/>
          </p:nvSpPr>
          <p:spPr>
            <a:xfrm>
              <a:off x="1414874" y="76200"/>
              <a:ext cx="41850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5" name="Group 54"/>
          <p:cNvGrpSpPr/>
          <p:nvPr/>
        </p:nvGrpSpPr>
        <p:grpSpPr>
          <a:xfrm>
            <a:off x="5810886" y="76199"/>
            <a:ext cx="2952114" cy="2253597"/>
            <a:chOff x="4780917" y="59393"/>
            <a:chExt cx="2952114" cy="2253597"/>
          </a:xfrm>
        </p:grpSpPr>
        <p:grpSp>
          <p:nvGrpSpPr>
            <p:cNvPr id="12" name="组合 11"/>
            <p:cNvGrpSpPr/>
            <p:nvPr/>
          </p:nvGrpSpPr>
          <p:grpSpPr>
            <a:xfrm>
              <a:off x="4987201" y="145071"/>
              <a:ext cx="1415436" cy="2167919"/>
              <a:chOff x="766980" y="2197632"/>
              <a:chExt cx="1415436" cy="2167919"/>
            </a:xfrm>
          </p:grpSpPr>
          <p:pic>
            <p:nvPicPr>
              <p:cNvPr id="13" name="Picture 2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4604"/>
              <a:stretch/>
            </p:blipFill>
            <p:spPr bwMode="auto">
              <a:xfrm>
                <a:off x="1115616" y="2197632"/>
                <a:ext cx="1066800" cy="179663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4" name="TextBox 13"/>
              <p:cNvSpPr txBox="1"/>
              <p:nvPr/>
            </p:nvSpPr>
            <p:spPr>
              <a:xfrm rot="18997173">
                <a:off x="838410" y="4119330"/>
                <a:ext cx="10669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latin typeface="Arial" pitchFamily="34" charset="0"/>
                    <a:cs typeface="Arial" pitchFamily="34" charset="0"/>
                  </a:rPr>
                  <a:t>H1975+DMSO</a:t>
                </a:r>
                <a:endParaRPr lang="zh-CN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 rot="18997173">
                <a:off x="1318855" y="4086938"/>
                <a:ext cx="81023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latin typeface="Arial" pitchFamily="34" charset="0"/>
                    <a:cs typeface="Arial" pitchFamily="34" charset="0"/>
                  </a:rPr>
                  <a:t>H1975+PF</a:t>
                </a:r>
                <a:endParaRPr lang="zh-CN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1740208" y="3460532"/>
                <a:ext cx="33490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766980" y="2197632"/>
                <a:ext cx="492443" cy="1905000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oft agar colony formation</a:t>
                </a:r>
              </a:p>
              <a:p>
                <a:pPr algn="ctr"/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(% of control cell)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8" name="TextBox 17"/>
            <p:cNvSpPr txBox="1"/>
            <p:nvPr/>
          </p:nvSpPr>
          <p:spPr>
            <a:xfrm>
              <a:off x="4780917" y="59393"/>
              <a:ext cx="41850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C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9" name="组合 18"/>
            <p:cNvGrpSpPr/>
            <p:nvPr/>
          </p:nvGrpSpPr>
          <p:grpSpPr>
            <a:xfrm>
              <a:off x="6395512" y="836329"/>
              <a:ext cx="1337519" cy="1006238"/>
              <a:chOff x="6622246" y="508484"/>
              <a:chExt cx="1337519" cy="1006238"/>
            </a:xfrm>
          </p:grpSpPr>
          <p:pic>
            <p:nvPicPr>
              <p:cNvPr id="20" name="Picture 2" descr="F:\Revise\soft agar\rev Image_1140.tif"/>
              <p:cNvPicPr preferRelativeResize="0">
                <a:picLocks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635757" y="1021522"/>
                <a:ext cx="475200" cy="4932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1" name="Picture 4" descr="F:\Revise\soft agar\rev Image_1157.tif"/>
              <p:cNvPicPr preferRelativeResize="0">
                <a:picLocks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144837" y="1021522"/>
                <a:ext cx="475200" cy="4932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2" name="TextBox 21"/>
              <p:cNvSpPr txBox="1"/>
              <p:nvPr/>
            </p:nvSpPr>
            <p:spPr>
              <a:xfrm rot="18997173">
                <a:off x="6622246" y="508484"/>
                <a:ext cx="10669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latin typeface="Arial" pitchFamily="34" charset="0"/>
                    <a:cs typeface="Arial" pitchFamily="34" charset="0"/>
                  </a:rPr>
                  <a:t>H1975+DMSO</a:t>
                </a:r>
                <a:endParaRPr lang="zh-CN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 rot="18997173">
                <a:off x="7149527" y="592433"/>
                <a:ext cx="81023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latin typeface="Arial" pitchFamily="34" charset="0"/>
                    <a:cs typeface="Arial" pitchFamily="34" charset="0"/>
                  </a:rPr>
                  <a:t>H1975+PF</a:t>
                </a:r>
                <a:endParaRPr lang="zh-CN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54" name="Group 53"/>
          <p:cNvGrpSpPr/>
          <p:nvPr/>
        </p:nvGrpSpPr>
        <p:grpSpPr>
          <a:xfrm>
            <a:off x="1021850" y="2701075"/>
            <a:ext cx="3016750" cy="2317527"/>
            <a:chOff x="576673" y="2701075"/>
            <a:chExt cx="3016750" cy="2317527"/>
          </a:xfrm>
        </p:grpSpPr>
        <p:sp>
          <p:nvSpPr>
            <p:cNvPr id="24" name="TextBox 23"/>
            <p:cNvSpPr txBox="1"/>
            <p:nvPr/>
          </p:nvSpPr>
          <p:spPr>
            <a:xfrm>
              <a:off x="576673" y="2718002"/>
              <a:ext cx="41850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D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5" name="组合 24"/>
            <p:cNvGrpSpPr/>
            <p:nvPr/>
          </p:nvGrpSpPr>
          <p:grpSpPr>
            <a:xfrm>
              <a:off x="837277" y="2701075"/>
              <a:ext cx="1381336" cy="2317527"/>
              <a:chOff x="2976964" y="1762479"/>
              <a:chExt cx="1381336" cy="2317527"/>
            </a:xfrm>
          </p:grpSpPr>
          <p:sp>
            <p:nvSpPr>
              <p:cNvPr id="26" name="TextBox 25"/>
              <p:cNvSpPr txBox="1"/>
              <p:nvPr/>
            </p:nvSpPr>
            <p:spPr>
              <a:xfrm rot="18997173">
                <a:off x="3013233" y="3833785"/>
                <a:ext cx="10669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latin typeface="Arial" pitchFamily="34" charset="0"/>
                    <a:cs typeface="Arial" pitchFamily="34" charset="0"/>
                  </a:rPr>
                  <a:t>H1975+DMSO</a:t>
                </a:r>
                <a:endParaRPr lang="zh-CN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 rot="18997173">
                <a:off x="3489124" y="3792601"/>
                <a:ext cx="81023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latin typeface="Arial" pitchFamily="34" charset="0"/>
                    <a:cs typeface="Arial" pitchFamily="34" charset="0"/>
                  </a:rPr>
                  <a:t>H1975+PF</a:t>
                </a:r>
                <a:endParaRPr lang="zh-CN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2976964" y="1762479"/>
                <a:ext cx="492443" cy="2111743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umber of migrating cells</a:t>
                </a:r>
              </a:p>
              <a:p>
                <a:pPr algn="ctr"/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(% of control cell)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3949064" y="3088790"/>
                <a:ext cx="33490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0" name="Picture 3"/>
              <p:cNvPicPr>
                <a:picLocks noChangeAspect="1" noChangeArrowheads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2159" b="22810"/>
              <a:stretch/>
            </p:blipFill>
            <p:spPr bwMode="auto">
              <a:xfrm>
                <a:off x="3351825" y="1902517"/>
                <a:ext cx="1006475" cy="178392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grpSp>
          <p:nvGrpSpPr>
            <p:cNvPr id="31" name="组合 30"/>
            <p:cNvGrpSpPr/>
            <p:nvPr/>
          </p:nvGrpSpPr>
          <p:grpSpPr>
            <a:xfrm>
              <a:off x="2217671" y="3562992"/>
              <a:ext cx="1375752" cy="1002827"/>
              <a:chOff x="5524848" y="1786541"/>
              <a:chExt cx="1375752" cy="1002827"/>
            </a:xfrm>
          </p:grpSpPr>
          <p:pic>
            <p:nvPicPr>
              <p:cNvPr id="32" name="Picture 2" descr="F:\Revise\Transwell\rev 111915 H23 36h re01.tif"/>
              <p:cNvPicPr preferRelativeResize="0">
                <a:picLocks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533366" y="2296168"/>
                <a:ext cx="475200" cy="4932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3" name="Picture 3" descr="F:\Revise\Transwell\rev 111315 A549 18h re01.tif"/>
              <p:cNvPicPr preferRelativeResize="0">
                <a:picLocks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055413" y="2296168"/>
                <a:ext cx="475200" cy="4932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34" name="TextBox 33"/>
              <p:cNvSpPr txBox="1"/>
              <p:nvPr/>
            </p:nvSpPr>
            <p:spPr>
              <a:xfrm rot="18997173">
                <a:off x="5524848" y="1786541"/>
                <a:ext cx="10669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latin typeface="Arial" pitchFamily="34" charset="0"/>
                    <a:cs typeface="Arial" pitchFamily="34" charset="0"/>
                  </a:rPr>
                  <a:t>H1975+DMSO</a:t>
                </a:r>
                <a:endParaRPr lang="zh-CN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 rot="18997173">
                <a:off x="6090362" y="1874700"/>
                <a:ext cx="81023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latin typeface="Arial" pitchFamily="34" charset="0"/>
                    <a:cs typeface="Arial" pitchFamily="34" charset="0"/>
                  </a:rPr>
                  <a:t>H1975+PF</a:t>
                </a:r>
                <a:endParaRPr lang="zh-CN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7" name="Group 6"/>
          <p:cNvGrpSpPr/>
          <p:nvPr/>
        </p:nvGrpSpPr>
        <p:grpSpPr>
          <a:xfrm>
            <a:off x="4748948" y="2749660"/>
            <a:ext cx="3861652" cy="2660540"/>
            <a:chOff x="4597151" y="2790110"/>
            <a:chExt cx="3861652" cy="2660540"/>
          </a:xfrm>
        </p:grpSpPr>
        <p:sp>
          <p:nvSpPr>
            <p:cNvPr id="36" name="TextBox 35"/>
            <p:cNvSpPr txBox="1"/>
            <p:nvPr/>
          </p:nvSpPr>
          <p:spPr>
            <a:xfrm>
              <a:off x="4597151" y="2790110"/>
              <a:ext cx="41850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E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7" name="组合 36"/>
            <p:cNvGrpSpPr/>
            <p:nvPr/>
          </p:nvGrpSpPr>
          <p:grpSpPr>
            <a:xfrm>
              <a:off x="4844629" y="3019657"/>
              <a:ext cx="1858889" cy="2430993"/>
              <a:chOff x="5161383" y="925999"/>
              <a:chExt cx="1858889" cy="2430993"/>
            </a:xfrm>
          </p:grpSpPr>
          <p:sp>
            <p:nvSpPr>
              <p:cNvPr id="38" name="TextBox 9"/>
              <p:cNvSpPr txBox="1"/>
              <p:nvPr/>
            </p:nvSpPr>
            <p:spPr>
              <a:xfrm>
                <a:off x="5161383" y="1196400"/>
                <a:ext cx="342051" cy="1057543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% Wound Area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39" name="图表 38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448544297"/>
                  </p:ext>
                </p:extLst>
              </p:nvPr>
            </p:nvGraphicFramePr>
            <p:xfrm>
              <a:off x="5364088" y="925999"/>
              <a:ext cx="1656184" cy="243099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  <p:sp>
            <p:nvSpPr>
              <p:cNvPr id="40" name="TextBox 39"/>
              <p:cNvSpPr txBox="1"/>
              <p:nvPr/>
            </p:nvSpPr>
            <p:spPr>
              <a:xfrm>
                <a:off x="6575411" y="1227681"/>
                <a:ext cx="1539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6652398" y="1484353"/>
                <a:ext cx="33490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2" name="组合 41"/>
            <p:cNvGrpSpPr/>
            <p:nvPr/>
          </p:nvGrpSpPr>
          <p:grpSpPr>
            <a:xfrm>
              <a:off x="6657896" y="3019099"/>
              <a:ext cx="1800907" cy="2214786"/>
              <a:chOff x="1259567" y="947724"/>
              <a:chExt cx="1800907" cy="2214786"/>
            </a:xfrm>
          </p:grpSpPr>
          <p:pic>
            <p:nvPicPr>
              <p:cNvPr id="43" name="Picture 3" descr="F:\Revise\Wound healing\rev 120315 A549 MMC seed07.tif"/>
              <p:cNvPicPr preferRelativeResize="0">
                <a:picLocks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66467" y="1450921"/>
                <a:ext cx="457200" cy="5472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4" name="Picture 7" descr="F:\Revise\Wound healing\rev 120615 H23 NO MMC SEED01.tif"/>
              <p:cNvPicPr preferRelativeResize="0">
                <a:picLocks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247815" y="2032295"/>
                <a:ext cx="457200" cy="5472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5" name="Picture 10" descr="F:\Revise\Wound healing\rev 120415 A549-SH-M MMC 24h11.tif"/>
              <p:cNvPicPr preferRelativeResize="0">
                <a:picLocks noChangeArrowheads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247815" y="2615310"/>
                <a:ext cx="457200" cy="5472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6" name="Picture 13" descr="F:\Revise\Wound healing\rev 120815 H23-SH-C 48H01.tif"/>
              <p:cNvPicPr preferRelativeResize="0">
                <a:picLocks noChangeArrowheads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65990" y="2615310"/>
                <a:ext cx="457200" cy="5472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7" name="Picture 15" descr="F:\Revise\Wound healing\rev 120515 A549 NO MMC 48h07.tif"/>
              <p:cNvPicPr preferRelativeResize="0">
                <a:picLocks noChangeArrowheads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766467" y="2031869"/>
                <a:ext cx="457200" cy="5472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8" name="Picture 2" descr="F:\Revise\Wound healing\rev 120315 A549 MMC seed10.tif"/>
              <p:cNvPicPr preferRelativeResize="0">
                <a:picLocks noChangeArrowheads="1"/>
              </p:cNvPicPr>
              <p:nvPr/>
            </p:nvPicPr>
            <p:blipFill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247815" y="1450921"/>
                <a:ext cx="457200" cy="5472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49" name="TextBox 48"/>
              <p:cNvSpPr txBox="1"/>
              <p:nvPr/>
            </p:nvSpPr>
            <p:spPr>
              <a:xfrm>
                <a:off x="1259567" y="2182358"/>
                <a:ext cx="5414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4 </a:t>
                </a:r>
                <a:r>
                  <a:rPr lang="en-US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r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1294847" y="2765798"/>
                <a:ext cx="47162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8 </a:t>
                </a:r>
                <a:r>
                  <a:rPr lang="en-US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r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1334064" y="1601410"/>
                <a:ext cx="46522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r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 rot="18997173">
                <a:off x="1742880" y="947724"/>
                <a:ext cx="10669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latin typeface="Arial" pitchFamily="34" charset="0"/>
                    <a:cs typeface="Arial" pitchFamily="34" charset="0"/>
                  </a:rPr>
                  <a:t>H1975+DMSO</a:t>
                </a:r>
                <a:endParaRPr lang="zh-CN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 rot="18997173">
                <a:off x="2250236" y="1035884"/>
                <a:ext cx="81023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smtClean="0">
                    <a:latin typeface="Arial" pitchFamily="34" charset="0"/>
                    <a:cs typeface="Arial" pitchFamily="34" charset="0"/>
                  </a:rPr>
                  <a:t>H1975+PF</a:t>
                </a:r>
                <a:endParaRPr lang="zh-CN" alt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2" name="TextBox 1"/>
          <p:cNvSpPr txBox="1"/>
          <p:nvPr/>
        </p:nvSpPr>
        <p:spPr>
          <a:xfrm>
            <a:off x="858228" y="5381118"/>
            <a:ext cx="772625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 MAP4K4 inhibitor suppresses lung adenocarcinoma cell functions. H1975 cell functions were assayed under DMSO or 3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PF-06260933 treatments at indicated time points. Data in line charts and column charts were shown as means ± SD, * and ** denote a statistically significant difference, p&lt;0.05 and p&lt;0.01 respectively, compared with H1975 cells treated with DMSO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H1975 cells were treated with DMSO or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F-06260933 (PF) for 24 hours. The cell lysates were collected 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indicated antibodies. (B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viability was measured by MTT assay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pictures and quantification of soft agar assay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pictures and quantification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invasion assay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E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pictures and quantification of wound healing assay.</a:t>
            </a:r>
          </a:p>
        </p:txBody>
      </p:sp>
      <p:pic>
        <p:nvPicPr>
          <p:cNvPr id="1030" name="Picture 6"/>
          <p:cNvPicPr>
            <a:picLocks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9592" y="1200424"/>
            <a:ext cx="676656" cy="1828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3951" y="983148"/>
            <a:ext cx="680313" cy="1828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2" name="Picture 8"/>
          <p:cNvPicPr>
            <a:picLocks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9592" y="1421874"/>
            <a:ext cx="676656" cy="1828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4" name="TextBox 63"/>
          <p:cNvSpPr txBox="1"/>
          <p:nvPr/>
        </p:nvSpPr>
        <p:spPr>
          <a:xfrm>
            <a:off x="391526" y="1401662"/>
            <a:ext cx="664634" cy="230832"/>
          </a:xfrm>
          <a:prstGeom prst="rect">
            <a:avLst/>
          </a:prstGeom>
          <a:noFill/>
        </p:spPr>
        <p:txBody>
          <a:bodyPr wrap="square" numCol="1" rtlCol="0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391526" y="1176448"/>
            <a:ext cx="664634" cy="230832"/>
          </a:xfrm>
          <a:prstGeom prst="rect">
            <a:avLst/>
          </a:prstGeom>
          <a:noFill/>
        </p:spPr>
        <p:txBody>
          <a:bodyPr wrap="square" numCol="1" rtlCol="0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EK1/2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262898" y="964088"/>
            <a:ext cx="7071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-MEK1/2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33" name="Picture 9"/>
          <p:cNvPicPr>
            <a:picLocks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3544" y="542384"/>
            <a:ext cx="676656" cy="1828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5" name="Picture 11"/>
          <p:cNvPicPr>
            <a:picLocks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3544" y="764232"/>
            <a:ext cx="676656" cy="1828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0" name="TextBox 69"/>
          <p:cNvSpPr txBox="1"/>
          <p:nvPr/>
        </p:nvSpPr>
        <p:spPr>
          <a:xfrm>
            <a:off x="268572" y="533400"/>
            <a:ext cx="7071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-ERK1/2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391526" y="730366"/>
            <a:ext cx="607484" cy="230832"/>
          </a:xfrm>
          <a:prstGeom prst="rect">
            <a:avLst/>
          </a:prstGeom>
          <a:noFill/>
        </p:spPr>
        <p:txBody>
          <a:bodyPr wrap="square" numCol="1" rtlCol="0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RK1/2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76200" y="76200"/>
            <a:ext cx="4185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1018629" y="1600200"/>
            <a:ext cx="5585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1975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 rot="18939282">
            <a:off x="941950" y="251506"/>
            <a:ext cx="52751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 rot="18939282">
            <a:off x="1241840" y="243029"/>
            <a:ext cx="52751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F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73165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</TotalTime>
  <Words>209</Words>
  <Application>Microsoft Office PowerPoint</Application>
  <PresentationFormat>全屏显示(4:3)</PresentationFormat>
  <Paragraphs>40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Theme</vt:lpstr>
      <vt:lpstr>PowerPoint 演示文稿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o, Chenxi</dc:creator>
  <cp:lastModifiedBy>xbany</cp:lastModifiedBy>
  <cp:revision>15</cp:revision>
  <dcterms:created xsi:type="dcterms:W3CDTF">2006-08-16T00:00:00Z</dcterms:created>
  <dcterms:modified xsi:type="dcterms:W3CDTF">2017-03-30T14:15:32Z</dcterms:modified>
</cp:coreProperties>
</file>